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57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6BFA2E-F172-2556-00E4-1D2C5CEC1308}" name="Sara Wienke" initials="SW" userId="S::swienke@guardanthealth.com::44f54943-3314-470e-928b-597200c85ffe" providerId="AD"/>
  <p188:author id="{1241055D-7DF1-DB9D-7BCF-C5A38B4AA1EF}" name="Jude Masannat" initials="JM" userId="S::jmasannat@guardanthealth.com::48affbf4-8ab1-4fc4-82db-3208965ad05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9086F0-2C37-5DE1-C34D-F00F4629F619}" v="1444" dt="2025-06-04T18:51:29.681"/>
    <p1510:client id="{0874E646-EC97-1512-A2A8-E71BD479369D}" v="6" dt="2025-06-04T15:15:52.442"/>
    <p1510:client id="{34D54C23-350A-0AD2-8DE1-0209BABF7BC1}" v="115" dt="2025-06-04T15:01:34.575"/>
    <p1510:client id="{3887DAEF-AFE3-2140-B2D4-4ED602B64044}" v="27" dt="2025-06-04T19:09:21.769"/>
    <p1510:client id="{55D52541-6774-4949-865A-8900D79EFBC7}" v="49" dt="2025-06-04T15:38:13.454"/>
    <p1510:client id="{B808C385-B51E-1C22-646C-B1EF128E60B1}" v="130" dt="2025-06-03T19:12:57.402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0"/>
    <p:restoredTop sz="94558"/>
  </p:normalViewPr>
  <p:slideViewPr>
    <p:cSldViewPr snapToGrid="0">
      <p:cViewPr varScale="1">
        <p:scale>
          <a:sx n="90" d="100"/>
          <a:sy n="90" d="100"/>
        </p:scale>
        <p:origin x="322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13F00-949A-7A41-BA11-E8DECFFB2187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333865-40B2-6249-89FB-0719449F8D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39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29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554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42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96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85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282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70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57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7F0721-00BC-7946-90BD-BB11BA514734}" type="datetimeFigureOut">
              <a:rPr lang="en-US" smtClean="0"/>
              <a:t>7/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40FAD3-053D-D04A-9DEB-A12674F423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5588499F-6EBB-BC9E-E9B1-F5E8031CC9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710" y="766916"/>
            <a:ext cx="3878825" cy="36815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5F69A78-BF77-48DB-6D2C-E183D26CC64E}"/>
              </a:ext>
            </a:extLst>
          </p:cNvPr>
          <p:cNvSpPr txBox="1"/>
          <p:nvPr/>
        </p:nvSpPr>
        <p:spPr>
          <a:xfrm>
            <a:off x="364172" y="4571999"/>
            <a:ext cx="388336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Supplementary </a:t>
            </a:r>
            <a:r>
              <a:rPr lang="en-US" sz="1000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Figure S1. Histogram showing the timing of sample collection post treatment where T1 in blue is defined as 15-105 days, T2 in yellow is defined as 106-272 days and T3 in green is defined as 273-450 days (n=627).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96C6617-ECCB-7CD5-A641-51EF765F2B76}"/>
              </a:ext>
            </a:extLst>
          </p:cNvPr>
          <p:cNvSpPr txBox="1"/>
          <p:nvPr/>
        </p:nvSpPr>
        <p:spPr>
          <a:xfrm>
            <a:off x="242887" y="27400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Supplementary 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733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0090abd-25aa-4ac3-b924-e35af8d9ed55">
      <Terms xmlns="http://schemas.microsoft.com/office/infopath/2007/PartnerControls"/>
    </lcf76f155ced4ddcb4097134ff3c332f>
    <TaxCatchAll xmlns="606ae6eb-d705-4ce8-b671-b906251446a9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7EAB79E8A649043B57FB7E201303455" ma:contentTypeVersion="14" ma:contentTypeDescription="Create a new document." ma:contentTypeScope="" ma:versionID="e71411c950fa83840c021bf03c814f63">
  <xsd:schema xmlns:xsd="http://www.w3.org/2001/XMLSchema" xmlns:xs="http://www.w3.org/2001/XMLSchema" xmlns:p="http://schemas.microsoft.com/office/2006/metadata/properties" xmlns:ns2="b0090abd-25aa-4ac3-b924-e35af8d9ed55" xmlns:ns3="606ae6eb-d705-4ce8-b671-b906251446a9" targetNamespace="http://schemas.microsoft.com/office/2006/metadata/properties" ma:root="true" ma:fieldsID="fa0abb8aea339e328f4d0d365659916b" ns2:_="" ns3:_="">
    <xsd:import namespace="b0090abd-25aa-4ac3-b924-e35af8d9ed55"/>
    <xsd:import namespace="606ae6eb-d705-4ce8-b671-b906251446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090abd-25aa-4ac3-b924-e35af8d9ed5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4" nillable="true" ma:taxonomy="true" ma:internalName="lcf76f155ced4ddcb4097134ff3c332f" ma:taxonomyFieldName="MediaServiceImageTags" ma:displayName="Image Tags" ma:readOnly="false" ma:fieldId="{5cf76f15-5ced-4ddc-b409-7134ff3c332f}" ma:taxonomyMulti="true" ma:sspId="a1d584be-b9fa-4213-aedc-5d44287790d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06ae6eb-d705-4ce8-b671-b906251446a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5" nillable="true" ma:displayName="Taxonomy Catch All Column" ma:hidden="true" ma:list="{d8541e83-b154-4cb1-97f5-e6365a08337c}" ma:internalName="TaxCatchAll" ma:showField="CatchAllData" ma:web="606ae6eb-d705-4ce8-b671-b906251446a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91CB7F9-EAA8-4639-93FB-092840FA0849}">
  <ds:schemaRefs>
    <ds:schemaRef ds:uri="b0090abd-25aa-4ac3-b924-e35af8d9ed55"/>
    <ds:schemaRef ds:uri="http://schemas.microsoft.com/office/2006/documentManagement/types"/>
    <ds:schemaRef ds:uri="http://purl.org/dc/elements/1.1/"/>
    <ds:schemaRef ds:uri="http://purl.org/dc/terms/"/>
    <ds:schemaRef ds:uri="http://schemas.microsoft.com/office/infopath/2007/PartnerControls"/>
    <ds:schemaRef ds:uri="606ae6eb-d705-4ce8-b671-b906251446a9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CFDCDCFB-A19A-47C2-A857-5A1E61AC3829}">
  <ds:schemaRefs>
    <ds:schemaRef ds:uri="606ae6eb-d705-4ce8-b671-b906251446a9"/>
    <ds:schemaRef ds:uri="b0090abd-25aa-4ac3-b924-e35af8d9ed55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AF058950-C37C-4A99-A679-DB3B38A1AE72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7</TotalTime>
  <Words>48</Words>
  <Application>Microsoft Macintosh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Wienke</dc:creator>
  <cp:lastModifiedBy>Samantha Liang</cp:lastModifiedBy>
  <cp:revision>14</cp:revision>
  <dcterms:created xsi:type="dcterms:W3CDTF">2024-12-13T18:22:33Z</dcterms:created>
  <dcterms:modified xsi:type="dcterms:W3CDTF">2025-07-09T17:18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7EAB79E8A649043B57FB7E201303455</vt:lpwstr>
  </property>
  <property fmtid="{D5CDD505-2E9C-101B-9397-08002B2CF9AE}" pid="3" name="MediaServiceImageTags">
    <vt:lpwstr/>
  </property>
</Properties>
</file>